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1" r:id="rId2"/>
    <p:sldId id="27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237299-33EC-4998-AE85-F1847DAB6CAF}" v="1" dt="2021-12-05T01:40:45.37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96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義明" userId="22914f78aa42735e" providerId="LiveId" clId="{E94EE2C3-1665-4AE6-9059-4594AEF7EE77}"/>
    <pc:docChg chg="custSel addSld modSld">
      <pc:chgData name="義明" userId="22914f78aa42735e" providerId="LiveId" clId="{E94EE2C3-1665-4AE6-9059-4594AEF7EE77}" dt="2021-11-12T07:50:16.441" v="9" actId="1076"/>
      <pc:docMkLst>
        <pc:docMk/>
      </pc:docMkLst>
      <pc:sldChg chg="addSp delSp modSp new mod modClrScheme chgLayout">
        <pc:chgData name="義明" userId="22914f78aa42735e" providerId="LiveId" clId="{E94EE2C3-1665-4AE6-9059-4594AEF7EE77}" dt="2021-11-12T07:46:56.965" v="5" actId="1076"/>
        <pc:sldMkLst>
          <pc:docMk/>
          <pc:sldMk cId="2928063732" sldId="257"/>
        </pc:sldMkLst>
        <pc:spChg chg="del">
          <ac:chgData name="義明" userId="22914f78aa42735e" providerId="LiveId" clId="{E94EE2C3-1665-4AE6-9059-4594AEF7EE77}" dt="2021-11-12T07:46:51.374" v="1" actId="700"/>
          <ac:spMkLst>
            <pc:docMk/>
            <pc:sldMk cId="2928063732" sldId="257"/>
            <ac:spMk id="2" creationId="{9DDD015C-91BA-4F8C-AD8E-8640F24104B2}"/>
          </ac:spMkLst>
        </pc:spChg>
        <pc:spChg chg="del">
          <ac:chgData name="義明" userId="22914f78aa42735e" providerId="LiveId" clId="{E94EE2C3-1665-4AE6-9059-4594AEF7EE77}" dt="2021-11-12T07:46:51.374" v="1" actId="700"/>
          <ac:spMkLst>
            <pc:docMk/>
            <pc:sldMk cId="2928063732" sldId="257"/>
            <ac:spMk id="3" creationId="{C27D817C-AE54-4B11-8066-106EA0D5AFAA}"/>
          </ac:spMkLst>
        </pc:spChg>
        <pc:picChg chg="add mod">
          <ac:chgData name="義明" userId="22914f78aa42735e" providerId="LiveId" clId="{E94EE2C3-1665-4AE6-9059-4594AEF7EE77}" dt="2021-11-12T07:46:56.965" v="5" actId="1076"/>
          <ac:picMkLst>
            <pc:docMk/>
            <pc:sldMk cId="2928063732" sldId="257"/>
            <ac:picMk id="5" creationId="{834FDB28-7DF4-4FE5-920A-CC6EF4ED6119}"/>
          </ac:picMkLst>
        </pc:picChg>
      </pc:sldChg>
      <pc:sldChg chg="addSp modSp new mod">
        <pc:chgData name="義明" userId="22914f78aa42735e" providerId="LiveId" clId="{E94EE2C3-1665-4AE6-9059-4594AEF7EE77}" dt="2021-11-12T07:50:16.441" v="9" actId="1076"/>
        <pc:sldMkLst>
          <pc:docMk/>
          <pc:sldMk cId="375995303" sldId="258"/>
        </pc:sldMkLst>
        <pc:picChg chg="add mod">
          <ac:chgData name="義明" userId="22914f78aa42735e" providerId="LiveId" clId="{E94EE2C3-1665-4AE6-9059-4594AEF7EE77}" dt="2021-11-12T07:50:16.441" v="9" actId="1076"/>
          <ac:picMkLst>
            <pc:docMk/>
            <pc:sldMk cId="375995303" sldId="258"/>
            <ac:picMk id="3" creationId="{A3F53BD7-A917-4A89-9A9E-39F098601AD8}"/>
          </ac:picMkLst>
        </pc:picChg>
      </pc:sldChg>
    </pc:docChg>
  </pc:docChgLst>
  <pc:docChgLst>
    <pc:chgData name="野村 義明" userId="22914f78aa42735e" providerId="LiveId" clId="{2C237299-33EC-4998-AE85-F1847DAB6CAF}"/>
    <pc:docChg chg="addSld modSld">
      <pc:chgData name="野村 義明" userId="22914f78aa42735e" providerId="LiveId" clId="{2C237299-33EC-4998-AE85-F1847DAB6CAF}" dt="2021-12-05T01:41:05.066" v="57" actId="20577"/>
      <pc:docMkLst>
        <pc:docMk/>
      </pc:docMkLst>
      <pc:sldChg chg="addSp new mod">
        <pc:chgData name="野村 義明" userId="22914f78aa42735e" providerId="LiveId" clId="{2C237299-33EC-4998-AE85-F1847DAB6CAF}" dt="2021-12-05T00:22:56.307" v="1" actId="22"/>
        <pc:sldMkLst>
          <pc:docMk/>
          <pc:sldMk cId="3251730616" sldId="266"/>
        </pc:sldMkLst>
        <pc:picChg chg="add">
          <ac:chgData name="野村 義明" userId="22914f78aa42735e" providerId="LiveId" clId="{2C237299-33EC-4998-AE85-F1847DAB6CAF}" dt="2021-12-05T00:22:56.307" v="1" actId="22"/>
          <ac:picMkLst>
            <pc:docMk/>
            <pc:sldMk cId="3251730616" sldId="266"/>
            <ac:picMk id="3" creationId="{3FC2FE41-2885-4D13-B450-BA6ED3191EFD}"/>
          </ac:picMkLst>
        </pc:picChg>
      </pc:sldChg>
      <pc:sldChg chg="addSp new mod">
        <pc:chgData name="野村 義明" userId="22914f78aa42735e" providerId="LiveId" clId="{2C237299-33EC-4998-AE85-F1847DAB6CAF}" dt="2021-12-05T00:26:08.486" v="3" actId="22"/>
        <pc:sldMkLst>
          <pc:docMk/>
          <pc:sldMk cId="1488087310" sldId="267"/>
        </pc:sldMkLst>
        <pc:picChg chg="add">
          <ac:chgData name="野村 義明" userId="22914f78aa42735e" providerId="LiveId" clId="{2C237299-33EC-4998-AE85-F1847DAB6CAF}" dt="2021-12-05T00:26:08.486" v="3" actId="22"/>
          <ac:picMkLst>
            <pc:docMk/>
            <pc:sldMk cId="1488087310" sldId="267"/>
            <ac:picMk id="3" creationId="{6333EA66-F039-43D8-B2DA-B28238690052}"/>
          </ac:picMkLst>
        </pc:picChg>
      </pc:sldChg>
      <pc:sldChg chg="addSp modSp new mod">
        <pc:chgData name="野村 義明" userId="22914f78aa42735e" providerId="LiveId" clId="{2C237299-33EC-4998-AE85-F1847DAB6CAF}" dt="2021-12-05T01:41:05.066" v="57" actId="20577"/>
        <pc:sldMkLst>
          <pc:docMk/>
          <pc:sldMk cId="4261591957" sldId="268"/>
        </pc:sldMkLst>
        <pc:spChg chg="add mod">
          <ac:chgData name="野村 義明" userId="22914f78aa42735e" providerId="LiveId" clId="{2C237299-33EC-4998-AE85-F1847DAB6CAF}" dt="2021-12-05T01:41:05.066" v="57" actId="20577"/>
          <ac:spMkLst>
            <pc:docMk/>
            <pc:sldMk cId="4261591957" sldId="268"/>
            <ac:spMk id="4" creationId="{78162A40-DD68-466B-AB8B-59AEAB163771}"/>
          </ac:spMkLst>
        </pc:spChg>
        <pc:picChg chg="add mod">
          <ac:chgData name="野村 義明" userId="22914f78aa42735e" providerId="LiveId" clId="{2C237299-33EC-4998-AE85-F1847DAB6CAF}" dt="2021-12-05T01:40:42.949" v="7" actId="14100"/>
          <ac:picMkLst>
            <pc:docMk/>
            <pc:sldMk cId="4261591957" sldId="268"/>
            <ac:picMk id="3" creationId="{17DCDB08-6072-402F-97FD-738E5C52D651}"/>
          </ac:picMkLst>
        </pc:picChg>
      </pc:sldChg>
    </pc:docChg>
  </pc:docChgLst>
  <pc:docChgLst>
    <pc:chgData name="義明" userId="22914f78aa42735e" providerId="LiveId" clId="{02349981-14D3-45F0-A5C9-A5FBB4DA95A2}"/>
    <pc:docChg chg="custSel addSld modSld">
      <pc:chgData name="義明" userId="22914f78aa42735e" providerId="LiveId" clId="{02349981-14D3-45F0-A5C9-A5FBB4DA95A2}" dt="2021-12-02T06:50:36.025" v="273" actId="1076"/>
      <pc:docMkLst>
        <pc:docMk/>
      </pc:docMkLst>
      <pc:sldChg chg="addSp modSp mod">
        <pc:chgData name="義明" userId="22914f78aa42735e" providerId="LiveId" clId="{02349981-14D3-45F0-A5C9-A5FBB4DA95A2}" dt="2021-12-02T05:30:26.960" v="15" actId="2711"/>
        <pc:sldMkLst>
          <pc:docMk/>
          <pc:sldMk cId="2928063732" sldId="257"/>
        </pc:sldMkLst>
        <pc:spChg chg="add mod">
          <ac:chgData name="義明" userId="22914f78aa42735e" providerId="LiveId" clId="{02349981-14D3-45F0-A5C9-A5FBB4DA95A2}" dt="2021-12-02T05:30:26.960" v="15" actId="2711"/>
          <ac:spMkLst>
            <pc:docMk/>
            <pc:sldMk cId="2928063732" sldId="257"/>
            <ac:spMk id="2" creationId="{7537261F-C55C-4A8C-8448-D59EA9CA99A5}"/>
          </ac:spMkLst>
        </pc:spChg>
      </pc:sldChg>
      <pc:sldChg chg="addSp modSp mod">
        <pc:chgData name="義明" userId="22914f78aa42735e" providerId="LiveId" clId="{02349981-14D3-45F0-A5C9-A5FBB4DA95A2}" dt="2021-12-02T05:33:04.757" v="58" actId="1076"/>
        <pc:sldMkLst>
          <pc:docMk/>
          <pc:sldMk cId="375995303" sldId="258"/>
        </pc:sldMkLst>
        <pc:spChg chg="add mod">
          <ac:chgData name="義明" userId="22914f78aa42735e" providerId="LiveId" clId="{02349981-14D3-45F0-A5C9-A5FBB4DA95A2}" dt="2021-12-02T05:33:04.757" v="58" actId="1076"/>
          <ac:spMkLst>
            <pc:docMk/>
            <pc:sldMk cId="375995303" sldId="258"/>
            <ac:spMk id="2" creationId="{9862CBE6-8D26-4A3F-8188-2E43D29CD8D3}"/>
          </ac:spMkLst>
        </pc:spChg>
        <pc:picChg chg="mod">
          <ac:chgData name="義明" userId="22914f78aa42735e" providerId="LiveId" clId="{02349981-14D3-45F0-A5C9-A5FBB4DA95A2}" dt="2021-12-02T05:29:41.226" v="0" actId="1076"/>
          <ac:picMkLst>
            <pc:docMk/>
            <pc:sldMk cId="375995303" sldId="258"/>
            <ac:picMk id="3" creationId="{A3F53BD7-A917-4A89-9A9E-39F098601AD8}"/>
          </ac:picMkLst>
        </pc:picChg>
      </pc:sldChg>
      <pc:sldChg chg="addSp delSp modSp new mod">
        <pc:chgData name="義明" userId="22914f78aa42735e" providerId="LiveId" clId="{02349981-14D3-45F0-A5C9-A5FBB4DA95A2}" dt="2021-12-02T06:01:47.608" v="184" actId="1076"/>
        <pc:sldMkLst>
          <pc:docMk/>
          <pc:sldMk cId="324999075" sldId="259"/>
        </pc:sldMkLst>
        <pc:spChg chg="add del mod">
          <ac:chgData name="義明" userId="22914f78aa42735e" providerId="LiveId" clId="{02349981-14D3-45F0-A5C9-A5FBB4DA95A2}" dt="2021-12-02T05:33:03.298" v="57"/>
          <ac:spMkLst>
            <pc:docMk/>
            <pc:sldMk cId="324999075" sldId="259"/>
            <ac:spMk id="5" creationId="{4AA67077-A324-4732-BA95-4343A852B9C2}"/>
          </ac:spMkLst>
        </pc:spChg>
        <pc:spChg chg="add mod">
          <ac:chgData name="義明" userId="22914f78aa42735e" providerId="LiveId" clId="{02349981-14D3-45F0-A5C9-A5FBB4DA95A2}" dt="2021-12-02T06:01:47.608" v="184" actId="1076"/>
          <ac:spMkLst>
            <pc:docMk/>
            <pc:sldMk cId="324999075" sldId="259"/>
            <ac:spMk id="7" creationId="{AD5670B1-E820-4ABB-AF8A-CA0DF4C1212D}"/>
          </ac:spMkLst>
        </pc:spChg>
        <pc:spChg chg="add mod">
          <ac:chgData name="義明" userId="22914f78aa42735e" providerId="LiveId" clId="{02349981-14D3-45F0-A5C9-A5FBB4DA95A2}" dt="2021-12-02T06:01:05.754" v="166" actId="1076"/>
          <ac:spMkLst>
            <pc:docMk/>
            <pc:sldMk cId="324999075" sldId="259"/>
            <ac:spMk id="10" creationId="{66E4D830-56C4-4190-8DED-3FB84E70E93C}"/>
          </ac:spMkLst>
        </pc:spChg>
        <pc:spChg chg="add mod">
          <ac:chgData name="義明" userId="22914f78aa42735e" providerId="LiveId" clId="{02349981-14D3-45F0-A5C9-A5FBB4DA95A2}" dt="2021-12-02T06:01:19.943" v="173" actId="20577"/>
          <ac:spMkLst>
            <pc:docMk/>
            <pc:sldMk cId="324999075" sldId="259"/>
            <ac:spMk id="11" creationId="{CB9FC643-CFD0-4014-A412-DB60D62E82CC}"/>
          </ac:spMkLst>
        </pc:spChg>
        <pc:picChg chg="add mod">
          <ac:chgData name="義明" userId="22914f78aa42735e" providerId="LiveId" clId="{02349981-14D3-45F0-A5C9-A5FBB4DA95A2}" dt="2021-12-02T06:00:28.909" v="148" actId="1076"/>
          <ac:picMkLst>
            <pc:docMk/>
            <pc:sldMk cId="324999075" sldId="259"/>
            <ac:picMk id="3" creationId="{6D51C577-4F54-46B1-AA03-67C73C90FCDF}"/>
          </ac:picMkLst>
        </pc:picChg>
        <pc:picChg chg="add mod">
          <ac:chgData name="義明" userId="22914f78aa42735e" providerId="LiveId" clId="{02349981-14D3-45F0-A5C9-A5FBB4DA95A2}" dt="2021-12-02T06:00:31.312" v="150" actId="1076"/>
          <ac:picMkLst>
            <pc:docMk/>
            <pc:sldMk cId="324999075" sldId="259"/>
            <ac:picMk id="9" creationId="{C3443117-AAAE-41E8-8454-687C17483399}"/>
          </ac:picMkLst>
        </pc:picChg>
      </pc:sldChg>
      <pc:sldChg chg="addSp delSp modSp new mod">
        <pc:chgData name="義明" userId="22914f78aa42735e" providerId="LiveId" clId="{02349981-14D3-45F0-A5C9-A5FBB4DA95A2}" dt="2021-12-02T06:02:16.630" v="190" actId="571"/>
        <pc:sldMkLst>
          <pc:docMk/>
          <pc:sldMk cId="3744015642" sldId="260"/>
        </pc:sldMkLst>
        <pc:spChg chg="add del mod">
          <ac:chgData name="義明" userId="22914f78aa42735e" providerId="LiveId" clId="{02349981-14D3-45F0-A5C9-A5FBB4DA95A2}" dt="2021-12-02T05:33:55.627" v="70" actId="478"/>
          <ac:spMkLst>
            <pc:docMk/>
            <pc:sldMk cId="3744015642" sldId="260"/>
            <ac:spMk id="3" creationId="{6E058253-3550-414D-985C-F978BB6C2A4A}"/>
          </ac:spMkLst>
        </pc:spChg>
        <pc:spChg chg="add mod">
          <ac:chgData name="義明" userId="22914f78aa42735e" providerId="LiveId" clId="{02349981-14D3-45F0-A5C9-A5FBB4DA95A2}" dt="2021-12-02T05:34:03.444" v="72" actId="1076"/>
          <ac:spMkLst>
            <pc:docMk/>
            <pc:sldMk cId="3744015642" sldId="260"/>
            <ac:spMk id="5" creationId="{44358F3E-E122-4DA2-83B0-647A9834FEE2}"/>
          </ac:spMkLst>
        </pc:spChg>
        <pc:spChg chg="add mod">
          <ac:chgData name="義明" userId="22914f78aa42735e" providerId="LiveId" clId="{02349981-14D3-45F0-A5C9-A5FBB4DA95A2}" dt="2021-12-02T06:02:01.175" v="186" actId="1076"/>
          <ac:spMkLst>
            <pc:docMk/>
            <pc:sldMk cId="3744015642" sldId="260"/>
            <ac:spMk id="14" creationId="{8921680E-20F7-48A4-8B58-E924F72EDF83}"/>
          </ac:spMkLst>
        </pc:spChg>
        <pc:spChg chg="add mod">
          <ac:chgData name="義明" userId="22914f78aa42735e" providerId="LiveId" clId="{02349981-14D3-45F0-A5C9-A5FBB4DA95A2}" dt="2021-12-02T06:02:03.889" v="187" actId="1076"/>
          <ac:spMkLst>
            <pc:docMk/>
            <pc:sldMk cId="3744015642" sldId="260"/>
            <ac:spMk id="15" creationId="{C844BC10-FF39-4FD3-8084-AA2627F59AD7}"/>
          </ac:spMkLst>
        </pc:spChg>
        <pc:spChg chg="add mod">
          <ac:chgData name="義明" userId="22914f78aa42735e" providerId="LiveId" clId="{02349981-14D3-45F0-A5C9-A5FBB4DA95A2}" dt="2021-12-02T06:02:13.758" v="189" actId="1076"/>
          <ac:spMkLst>
            <pc:docMk/>
            <pc:sldMk cId="3744015642" sldId="260"/>
            <ac:spMk id="16" creationId="{0B63F70B-C4FC-48AA-B18A-E6C696B63459}"/>
          </ac:spMkLst>
        </pc:spChg>
        <pc:spChg chg="add mod">
          <ac:chgData name="義明" userId="22914f78aa42735e" providerId="LiveId" clId="{02349981-14D3-45F0-A5C9-A5FBB4DA95A2}" dt="2021-12-02T06:02:13.758" v="189" actId="1076"/>
          <ac:spMkLst>
            <pc:docMk/>
            <pc:sldMk cId="3744015642" sldId="260"/>
            <ac:spMk id="17" creationId="{ED26FFAB-0001-40E3-8C3C-2BD3582A8887}"/>
          </ac:spMkLst>
        </pc:spChg>
        <pc:spChg chg="add mod">
          <ac:chgData name="義明" userId="22914f78aa42735e" providerId="LiveId" clId="{02349981-14D3-45F0-A5C9-A5FBB4DA95A2}" dt="2021-12-02T06:02:16.630" v="190" actId="571"/>
          <ac:spMkLst>
            <pc:docMk/>
            <pc:sldMk cId="3744015642" sldId="260"/>
            <ac:spMk id="18" creationId="{162B06BF-5BF8-4860-8327-30A34DBEBD55}"/>
          </ac:spMkLst>
        </pc:spChg>
        <pc:spChg chg="add mod">
          <ac:chgData name="義明" userId="22914f78aa42735e" providerId="LiveId" clId="{02349981-14D3-45F0-A5C9-A5FBB4DA95A2}" dt="2021-12-02T06:02:16.630" v="190" actId="571"/>
          <ac:spMkLst>
            <pc:docMk/>
            <pc:sldMk cId="3744015642" sldId="260"/>
            <ac:spMk id="19" creationId="{95B94C51-36DE-4A33-BDB5-4BD554F1CCAC}"/>
          </ac:spMkLst>
        </pc:spChg>
        <pc:spChg chg="add mod">
          <ac:chgData name="義明" userId="22914f78aa42735e" providerId="LiveId" clId="{02349981-14D3-45F0-A5C9-A5FBB4DA95A2}" dt="2021-12-02T06:02:16.630" v="190" actId="571"/>
          <ac:spMkLst>
            <pc:docMk/>
            <pc:sldMk cId="3744015642" sldId="260"/>
            <ac:spMk id="20" creationId="{C6D81E91-8BFB-4E1B-A45E-37E0A32DB61C}"/>
          </ac:spMkLst>
        </pc:spChg>
        <pc:picChg chg="add mod">
          <ac:chgData name="義明" userId="22914f78aa42735e" providerId="LiveId" clId="{02349981-14D3-45F0-A5C9-A5FBB4DA95A2}" dt="2021-12-02T05:36:40.070" v="91" actId="1076"/>
          <ac:picMkLst>
            <pc:docMk/>
            <pc:sldMk cId="3744015642" sldId="260"/>
            <ac:picMk id="7" creationId="{93B6058C-D281-4504-A63B-4D2E54BC7C2E}"/>
          </ac:picMkLst>
        </pc:picChg>
        <pc:picChg chg="add mod">
          <ac:chgData name="義明" userId="22914f78aa42735e" providerId="LiveId" clId="{02349981-14D3-45F0-A5C9-A5FBB4DA95A2}" dt="2021-12-02T05:45:33.418" v="103" actId="1076"/>
          <ac:picMkLst>
            <pc:docMk/>
            <pc:sldMk cId="3744015642" sldId="260"/>
            <ac:picMk id="9" creationId="{C7E91848-66B5-42A8-8530-046F0B7BC9AF}"/>
          </ac:picMkLst>
        </pc:picChg>
        <pc:picChg chg="add mod">
          <ac:chgData name="義明" userId="22914f78aa42735e" providerId="LiveId" clId="{02349981-14D3-45F0-A5C9-A5FBB4DA95A2}" dt="2021-12-02T05:59:35.742" v="138" actId="1076"/>
          <ac:picMkLst>
            <pc:docMk/>
            <pc:sldMk cId="3744015642" sldId="260"/>
            <ac:picMk id="11" creationId="{9441ED35-5C9B-4111-B52D-24B468B605AB}"/>
          </ac:picMkLst>
        </pc:picChg>
        <pc:picChg chg="add mod">
          <ac:chgData name="義明" userId="22914f78aa42735e" providerId="LiveId" clId="{02349981-14D3-45F0-A5C9-A5FBB4DA95A2}" dt="2021-12-02T05:59:34.558" v="137" actId="1076"/>
          <ac:picMkLst>
            <pc:docMk/>
            <pc:sldMk cId="3744015642" sldId="260"/>
            <ac:picMk id="13" creationId="{14CE4582-4EDE-4745-B3CE-559C0668C82D}"/>
          </ac:picMkLst>
        </pc:picChg>
      </pc:sldChg>
      <pc:sldChg chg="addSp modSp new mod">
        <pc:chgData name="義明" userId="22914f78aa42735e" providerId="LiveId" clId="{02349981-14D3-45F0-A5C9-A5FBB4DA95A2}" dt="2021-12-02T06:02:40.325" v="196" actId="1076"/>
        <pc:sldMkLst>
          <pc:docMk/>
          <pc:sldMk cId="1566236858" sldId="261"/>
        </pc:sldMkLst>
        <pc:spChg chg="add mod">
          <ac:chgData name="義明" userId="22914f78aa42735e" providerId="LiveId" clId="{02349981-14D3-45F0-A5C9-A5FBB4DA95A2}" dt="2021-12-02T05:36:31.358" v="88" actId="108"/>
          <ac:spMkLst>
            <pc:docMk/>
            <pc:sldMk cId="1566236858" sldId="261"/>
            <ac:spMk id="5" creationId="{E4542C6A-049A-481A-A9EB-5666C1F3475D}"/>
          </ac:spMkLst>
        </pc:spChg>
        <pc:spChg chg="add mod">
          <ac:chgData name="義明" userId="22914f78aa42735e" providerId="LiveId" clId="{02349981-14D3-45F0-A5C9-A5FBB4DA95A2}" dt="2021-12-02T06:02:30.145" v="195" actId="1076"/>
          <ac:spMkLst>
            <pc:docMk/>
            <pc:sldMk cId="1566236858" sldId="261"/>
            <ac:spMk id="12" creationId="{A527CB6B-C850-4C46-8C41-1A474CF634CA}"/>
          </ac:spMkLst>
        </pc:spChg>
        <pc:spChg chg="add mod">
          <ac:chgData name="義明" userId="22914f78aa42735e" providerId="LiveId" clId="{02349981-14D3-45F0-A5C9-A5FBB4DA95A2}" dt="2021-12-02T06:02:40.325" v="196" actId="1076"/>
          <ac:spMkLst>
            <pc:docMk/>
            <pc:sldMk cId="1566236858" sldId="261"/>
            <ac:spMk id="13" creationId="{6FC98B26-F243-48A8-98CF-04C21D0A7F02}"/>
          </ac:spMkLst>
        </pc:spChg>
        <pc:spChg chg="add mod">
          <ac:chgData name="義明" userId="22914f78aa42735e" providerId="LiveId" clId="{02349981-14D3-45F0-A5C9-A5FBB4DA95A2}" dt="2021-12-02T06:02:22.663" v="191"/>
          <ac:spMkLst>
            <pc:docMk/>
            <pc:sldMk cId="1566236858" sldId="261"/>
            <ac:spMk id="14" creationId="{AA96B7B9-3C35-4E7D-8541-2932FC669272}"/>
          </ac:spMkLst>
        </pc:spChg>
        <pc:spChg chg="add mod">
          <ac:chgData name="義明" userId="22914f78aa42735e" providerId="LiveId" clId="{02349981-14D3-45F0-A5C9-A5FBB4DA95A2}" dt="2021-12-02T06:02:27.725" v="194" actId="1076"/>
          <ac:spMkLst>
            <pc:docMk/>
            <pc:sldMk cId="1566236858" sldId="261"/>
            <ac:spMk id="15" creationId="{74AA61B0-7126-4820-9CA0-0341A298FC8A}"/>
          </ac:spMkLst>
        </pc:spChg>
        <pc:picChg chg="add mod">
          <ac:chgData name="義明" userId="22914f78aa42735e" providerId="LiveId" clId="{02349981-14D3-45F0-A5C9-A5FBB4DA95A2}" dt="2021-12-02T05:46:18.776" v="110" actId="1076"/>
          <ac:picMkLst>
            <pc:docMk/>
            <pc:sldMk cId="1566236858" sldId="261"/>
            <ac:picMk id="3" creationId="{E0F6D43A-8442-4A37-A3D3-1B0C58791435}"/>
          </ac:picMkLst>
        </pc:picChg>
        <pc:picChg chg="add mod">
          <ac:chgData name="義明" userId="22914f78aa42735e" providerId="LiveId" clId="{02349981-14D3-45F0-A5C9-A5FBB4DA95A2}" dt="2021-12-02T05:46:20.375" v="111" actId="1076"/>
          <ac:picMkLst>
            <pc:docMk/>
            <pc:sldMk cId="1566236858" sldId="261"/>
            <ac:picMk id="7" creationId="{E842E272-DE72-414C-B673-5891F3EBCA6A}"/>
          </ac:picMkLst>
        </pc:picChg>
        <pc:picChg chg="add mod">
          <ac:chgData name="義明" userId="22914f78aa42735e" providerId="LiveId" clId="{02349981-14D3-45F0-A5C9-A5FBB4DA95A2}" dt="2021-12-02T06:02:24.843" v="192" actId="1076"/>
          <ac:picMkLst>
            <pc:docMk/>
            <pc:sldMk cId="1566236858" sldId="261"/>
            <ac:picMk id="9" creationId="{43C5C678-072E-4950-90A8-AF0CF2C65619}"/>
          </ac:picMkLst>
        </pc:picChg>
        <pc:picChg chg="add mod">
          <ac:chgData name="義明" userId="22914f78aa42735e" providerId="LiveId" clId="{02349981-14D3-45F0-A5C9-A5FBB4DA95A2}" dt="2021-12-02T06:02:25.822" v="193" actId="1076"/>
          <ac:picMkLst>
            <pc:docMk/>
            <pc:sldMk cId="1566236858" sldId="261"/>
            <ac:picMk id="11" creationId="{A7C1E37C-BA6C-48D6-82C2-A7618E7D4812}"/>
          </ac:picMkLst>
        </pc:picChg>
      </pc:sldChg>
      <pc:sldChg chg="addSp modSp new mod">
        <pc:chgData name="義明" userId="22914f78aa42735e" providerId="LiveId" clId="{02349981-14D3-45F0-A5C9-A5FBB4DA95A2}" dt="2021-12-02T06:01:43.823" v="183" actId="1076"/>
        <pc:sldMkLst>
          <pc:docMk/>
          <pc:sldMk cId="2739561149" sldId="262"/>
        </pc:sldMkLst>
        <pc:spChg chg="add mod">
          <ac:chgData name="義明" userId="22914f78aa42735e" providerId="LiveId" clId="{02349981-14D3-45F0-A5C9-A5FBB4DA95A2}" dt="2021-12-02T06:01:32.264" v="178" actId="20577"/>
          <ac:spMkLst>
            <pc:docMk/>
            <pc:sldMk cId="2739561149" sldId="262"/>
            <ac:spMk id="6" creationId="{C95B5DDD-BC2D-4384-838B-F2D0148ED493}"/>
          </ac:spMkLst>
        </pc:spChg>
        <pc:spChg chg="add mod">
          <ac:chgData name="義明" userId="22914f78aa42735e" providerId="LiveId" clId="{02349981-14D3-45F0-A5C9-A5FBB4DA95A2}" dt="2021-12-02T06:01:43.823" v="183" actId="1076"/>
          <ac:spMkLst>
            <pc:docMk/>
            <pc:sldMk cId="2739561149" sldId="262"/>
            <ac:spMk id="7" creationId="{41EAF50C-7BA8-4477-A87E-68564185E5BC}"/>
          </ac:spMkLst>
        </pc:spChg>
        <pc:picChg chg="add mod">
          <ac:chgData name="義明" userId="22914f78aa42735e" providerId="LiveId" clId="{02349981-14D3-45F0-A5C9-A5FBB4DA95A2}" dt="2021-12-02T06:00:25.525" v="146" actId="1076"/>
          <ac:picMkLst>
            <pc:docMk/>
            <pc:sldMk cId="2739561149" sldId="262"/>
            <ac:picMk id="3" creationId="{D3ED4B51-E444-42A2-87A6-41517474DCFC}"/>
          </ac:picMkLst>
        </pc:picChg>
        <pc:picChg chg="add mod">
          <ac:chgData name="義明" userId="22914f78aa42735e" providerId="LiveId" clId="{02349981-14D3-45F0-A5C9-A5FBB4DA95A2}" dt="2021-12-02T06:00:26.780" v="147" actId="1076"/>
          <ac:picMkLst>
            <pc:docMk/>
            <pc:sldMk cId="2739561149" sldId="262"/>
            <ac:picMk id="5" creationId="{5F4FCBB3-5410-4575-8A94-52FBA7E7EB2B}"/>
          </ac:picMkLst>
        </pc:picChg>
      </pc:sldChg>
      <pc:sldChg chg="addSp modSp new mod">
        <pc:chgData name="義明" userId="22914f78aa42735e" providerId="LiveId" clId="{02349981-14D3-45F0-A5C9-A5FBB4DA95A2}" dt="2021-12-02T06:48:37.492" v="245"/>
        <pc:sldMkLst>
          <pc:docMk/>
          <pc:sldMk cId="3070589596" sldId="263"/>
        </pc:sldMkLst>
        <pc:spChg chg="add mod">
          <ac:chgData name="義明" userId="22914f78aa42735e" providerId="LiveId" clId="{02349981-14D3-45F0-A5C9-A5FBB4DA95A2}" dt="2021-12-02T06:48:37.492" v="245"/>
          <ac:spMkLst>
            <pc:docMk/>
            <pc:sldMk cId="3070589596" sldId="263"/>
            <ac:spMk id="10" creationId="{AEC46B3C-569B-4076-B6BC-59EC0BCD05FA}"/>
          </ac:spMkLst>
        </pc:spChg>
        <pc:spChg chg="add mod">
          <ac:chgData name="義明" userId="22914f78aa42735e" providerId="LiveId" clId="{02349981-14D3-45F0-A5C9-A5FBB4DA95A2}" dt="2021-12-02T06:48:37.492" v="245"/>
          <ac:spMkLst>
            <pc:docMk/>
            <pc:sldMk cId="3070589596" sldId="263"/>
            <ac:spMk id="11" creationId="{B548E44F-51FC-4AAD-945C-5C2595C6CAC3}"/>
          </ac:spMkLst>
        </pc:spChg>
        <pc:spChg chg="add mod">
          <ac:chgData name="義明" userId="22914f78aa42735e" providerId="LiveId" clId="{02349981-14D3-45F0-A5C9-A5FBB4DA95A2}" dt="2021-12-02T06:48:37.492" v="245"/>
          <ac:spMkLst>
            <pc:docMk/>
            <pc:sldMk cId="3070589596" sldId="263"/>
            <ac:spMk id="12" creationId="{2B061BA3-E841-4927-9627-A23335E7423C}"/>
          </ac:spMkLst>
        </pc:spChg>
        <pc:spChg chg="add mod">
          <ac:chgData name="義明" userId="22914f78aa42735e" providerId="LiveId" clId="{02349981-14D3-45F0-A5C9-A5FBB4DA95A2}" dt="2021-12-02T06:48:37.492" v="245"/>
          <ac:spMkLst>
            <pc:docMk/>
            <pc:sldMk cId="3070589596" sldId="263"/>
            <ac:spMk id="13" creationId="{D6CE2C8A-183A-4AF9-A40E-D0C17B8DDF6D}"/>
          </ac:spMkLst>
        </pc:spChg>
        <pc:picChg chg="add mod">
          <ac:chgData name="義明" userId="22914f78aa42735e" providerId="LiveId" clId="{02349981-14D3-45F0-A5C9-A5FBB4DA95A2}" dt="2021-12-02T06:20:28.219" v="217" actId="1076"/>
          <ac:picMkLst>
            <pc:docMk/>
            <pc:sldMk cId="3070589596" sldId="263"/>
            <ac:picMk id="3" creationId="{BEE50FE9-7CE9-40E2-B7AE-7E82A40A1AFC}"/>
          </ac:picMkLst>
        </pc:picChg>
        <pc:picChg chg="add mod">
          <ac:chgData name="義明" userId="22914f78aa42735e" providerId="LiveId" clId="{02349981-14D3-45F0-A5C9-A5FBB4DA95A2}" dt="2021-12-02T06:20:31.665" v="219" actId="1076"/>
          <ac:picMkLst>
            <pc:docMk/>
            <pc:sldMk cId="3070589596" sldId="263"/>
            <ac:picMk id="5" creationId="{B4441BAF-58F3-4B04-8821-56F9C1D88379}"/>
          </ac:picMkLst>
        </pc:picChg>
        <pc:picChg chg="add mod">
          <ac:chgData name="義明" userId="22914f78aa42735e" providerId="LiveId" clId="{02349981-14D3-45F0-A5C9-A5FBB4DA95A2}" dt="2021-12-02T06:20:24.259" v="214" actId="1076"/>
          <ac:picMkLst>
            <pc:docMk/>
            <pc:sldMk cId="3070589596" sldId="263"/>
            <ac:picMk id="7" creationId="{44A20497-05F3-4293-A9BB-60052D6AE89C}"/>
          </ac:picMkLst>
        </pc:picChg>
        <pc:picChg chg="add mod">
          <ac:chgData name="義明" userId="22914f78aa42735e" providerId="LiveId" clId="{02349981-14D3-45F0-A5C9-A5FBB4DA95A2}" dt="2021-12-02T06:21:34.292" v="225" actId="1076"/>
          <ac:picMkLst>
            <pc:docMk/>
            <pc:sldMk cId="3070589596" sldId="263"/>
            <ac:picMk id="9" creationId="{CF6EB306-37AA-4C44-B9D3-C6CDC223A76F}"/>
          </ac:picMkLst>
        </pc:picChg>
      </pc:sldChg>
      <pc:sldChg chg="addSp delSp modSp new mod">
        <pc:chgData name="義明" userId="22914f78aa42735e" providerId="LiveId" clId="{02349981-14D3-45F0-A5C9-A5FBB4DA95A2}" dt="2021-12-02T06:49:18.290" v="257" actId="1076"/>
        <pc:sldMkLst>
          <pc:docMk/>
          <pc:sldMk cId="4207271848" sldId="264"/>
        </pc:sldMkLst>
        <pc:spChg chg="add mod">
          <ac:chgData name="義明" userId="22914f78aa42735e" providerId="LiveId" clId="{02349981-14D3-45F0-A5C9-A5FBB4DA95A2}" dt="2021-12-02T06:49:18.290" v="257" actId="1076"/>
          <ac:spMkLst>
            <pc:docMk/>
            <pc:sldMk cId="4207271848" sldId="264"/>
            <ac:spMk id="4" creationId="{B8965029-9E5C-4139-B934-2C1C1CD71F25}"/>
          </ac:spMkLst>
        </pc:spChg>
        <pc:spChg chg="add del mod">
          <ac:chgData name="義明" userId="22914f78aa42735e" providerId="LiveId" clId="{02349981-14D3-45F0-A5C9-A5FBB4DA95A2}" dt="2021-12-02T06:49:15.696" v="256" actId="478"/>
          <ac:spMkLst>
            <pc:docMk/>
            <pc:sldMk cId="4207271848" sldId="264"/>
            <ac:spMk id="5" creationId="{6384EF12-8AC4-4603-8C97-B65641648DDF}"/>
          </ac:spMkLst>
        </pc:spChg>
        <pc:spChg chg="add mod">
          <ac:chgData name="義明" userId="22914f78aa42735e" providerId="LiveId" clId="{02349981-14D3-45F0-A5C9-A5FBB4DA95A2}" dt="2021-12-02T06:49:12.808" v="255" actId="14100"/>
          <ac:spMkLst>
            <pc:docMk/>
            <pc:sldMk cId="4207271848" sldId="264"/>
            <ac:spMk id="7" creationId="{D49C77CD-B6A9-4472-ADAB-D078598B44B8}"/>
          </ac:spMkLst>
        </pc:spChg>
        <pc:picChg chg="add mod">
          <ac:chgData name="義明" userId="22914f78aa42735e" providerId="LiveId" clId="{02349981-14D3-45F0-A5C9-A5FBB4DA95A2}" dt="2021-12-02T06:48:40.184" v="246" actId="1076"/>
          <ac:picMkLst>
            <pc:docMk/>
            <pc:sldMk cId="4207271848" sldId="264"/>
            <ac:picMk id="3" creationId="{BD817911-472B-4AF4-A3D9-28A557DA62E1}"/>
          </ac:picMkLst>
        </pc:picChg>
      </pc:sldChg>
      <pc:sldChg chg="addSp modSp new mod">
        <pc:chgData name="義明" userId="22914f78aa42735e" providerId="LiveId" clId="{02349981-14D3-45F0-A5C9-A5FBB4DA95A2}" dt="2021-12-02T06:50:36.025" v="273" actId="1076"/>
        <pc:sldMkLst>
          <pc:docMk/>
          <pc:sldMk cId="3013285963" sldId="265"/>
        </pc:sldMkLst>
        <pc:spChg chg="add mod">
          <ac:chgData name="義明" userId="22914f78aa42735e" providerId="LiveId" clId="{02349981-14D3-45F0-A5C9-A5FBB4DA95A2}" dt="2021-12-02T06:49:24.428" v="259"/>
          <ac:spMkLst>
            <pc:docMk/>
            <pc:sldMk cId="3013285963" sldId="265"/>
            <ac:spMk id="2" creationId="{F9B2352A-8D07-4D53-8927-D1F7E31AFBE7}"/>
          </ac:spMkLst>
        </pc:spChg>
        <pc:spChg chg="add mod">
          <ac:chgData name="義明" userId="22914f78aa42735e" providerId="LiveId" clId="{02349981-14D3-45F0-A5C9-A5FBB4DA95A2}" dt="2021-12-02T06:49:50.358" v="265" actId="1076"/>
          <ac:spMkLst>
            <pc:docMk/>
            <pc:sldMk cId="3013285963" sldId="265"/>
            <ac:spMk id="4" creationId="{97752193-1C55-4532-A881-579181CDFAD6}"/>
          </ac:spMkLst>
        </pc:spChg>
        <pc:picChg chg="add mod">
          <ac:chgData name="義明" userId="22914f78aa42735e" providerId="LiveId" clId="{02349981-14D3-45F0-A5C9-A5FBB4DA95A2}" dt="2021-12-02T06:50:09.475" v="269" actId="1076"/>
          <ac:picMkLst>
            <pc:docMk/>
            <pc:sldMk cId="3013285963" sldId="265"/>
            <ac:picMk id="6" creationId="{26C49F38-427E-40D4-8EE3-5697ADD93137}"/>
          </ac:picMkLst>
        </pc:picChg>
        <pc:picChg chg="add mod">
          <ac:chgData name="義明" userId="22914f78aa42735e" providerId="LiveId" clId="{02349981-14D3-45F0-A5C9-A5FBB4DA95A2}" dt="2021-12-02T06:50:36.025" v="273" actId="1076"/>
          <ac:picMkLst>
            <pc:docMk/>
            <pc:sldMk cId="3013285963" sldId="265"/>
            <ac:picMk id="8" creationId="{9359413E-D124-440B-90DC-7847923E8D58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CDE19F-428F-A44D-A0F6-398CF5DC91A4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D48279-4367-6D40-9EE3-F46BC33AD2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700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8F61C5-1125-40F0-8285-35C49C5A84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2F4A704-7746-4849-88EA-33C969AFC2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289E76-1966-4619-9DFA-D5A71D1D3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C02C61-8E62-4826-B4EC-4C7A735DC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B1FE87-B612-4F54-8506-7C1D55009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154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7C85E7-7A7E-44EF-A4E5-31F5166964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D69CBA7-7EA5-42D5-A93B-A682EBC30B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09BE4-F465-4AE7-A9D4-069D986FD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2DD040-DB15-4086-856F-80B06AB6A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5AB5569-C60D-40BA-8313-7F8BA74C6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765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21B7BF1-09D9-4EAF-A15A-C171FF55A1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77DC00F-F314-4EE7-8AD9-996B8A03F9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D8C4AC-ABE4-4C79-AB71-640055352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CE935F-714C-4C7B-B96D-A05008B65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F448E7-77E4-4966-95A5-952425B93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494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3C9466-AD6A-4077-9DA1-C820C80CE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7A69BC-CAEB-488B-B228-9BF0649550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40FE75-2406-4E37-861E-D378B8D50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06030F-401E-4A14-B9EF-44456B568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726D3B-BC06-4B6E-B91F-1C9396F03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60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718EFE-F7FC-49F1-89A6-7A81EF949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8F3B5BF-144F-4B24-BC37-0ADBB87EB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F81189-AE13-4FD2-984E-5D3E70D55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B46C7F-AEF1-491C-8BE5-0BE0AE1E7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19AEA4-76E2-4051-95B7-1E7975001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934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7D9773-8D8F-4B9C-AF65-0C59C3FBF1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3D085C9-2481-4EE1-8533-CD95BAC430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FD4A74-03C4-4E39-B5D8-855399472D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5945E3-008C-40CC-9785-DDEA99B26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321E2C-4548-4EAC-9CB1-DA2DCB3BC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8520308-64DA-4084-A4F5-7E37236B2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092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27C69D-D0B3-4BDF-8032-D1F621A339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D9CD76-38E4-4E8A-970E-9EC1625028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F40E6EF-4432-4F5E-91B8-682440FA6C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4C8026C-1340-4BE3-BE3B-E6C78D3557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6BA2DAF-A607-4470-92C3-4B78966960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4D827D5-D1E2-4DC0-A98E-84FF29473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5611433-89A8-4AB9-9C9B-6A4910BF9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20EA196-7898-4EE2-8093-0B9982F1C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283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AEABF3-97E9-427D-A93F-761FDC2C0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8684EB9-12DC-4C9E-BC14-63B7D66B9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45705CD-DD37-4E4C-8EC3-C760E6946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5854D87-CF94-4B1D-97AB-29F866818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622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B17E4D1-2793-4525-8413-B8618D8F8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CABE7E7-AB75-44A1-B57D-FC3CBA366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10061CE-E06E-4E0E-B892-4077A9565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8623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F5D2DC-74A0-431C-8662-0FDEC932E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7D64D93-C3DE-4483-9EE6-A419ED4695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CE8A871-A5D3-440C-9412-4EE5D92BE8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93266B-0B48-43AB-ABDA-F62C94830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E892B6B-D6BF-44B2-9168-644A6D7E2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903B76-4AB8-4FCB-A2E9-F1B0A6BB5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827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B4F02C-F751-459A-A261-0C7831820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52EE5F5-9E6C-41EA-B1B8-75E006876C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88679A2-7E8E-47C4-9FE5-E39146C2EF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7E5AD54-2606-47BA-B268-DA045EED0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A9345D5-C2EE-435F-8BCD-CFE8A490C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37BBF2-A238-4A40-84D9-EC4797F5A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3479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C03FA3A-09CA-4029-84ED-7A73BF5B96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1372BB-BAA1-48CC-BB5E-9A1C1DFADD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1734A5-D8BC-4BF9-89D9-7C0BCEC977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3CB5-120F-48A5-BCF2-F21760B1068B}" type="datetimeFigureOut">
              <a:rPr kumimoji="1" lang="ja-JP" altLang="en-US" smtClean="0"/>
              <a:t>2025/5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1084E7-8F82-400B-8677-E358567DEA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B9E1E3-4B51-40B3-97BE-BA47D3765C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508EC-414A-4DA9-834B-23100B4EEC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142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F53B6A1-23ED-4626-81DE-5423968BBCC4}"/>
              </a:ext>
            </a:extLst>
          </p:cNvPr>
          <p:cNvSpPr txBox="1"/>
          <p:nvPr/>
        </p:nvSpPr>
        <p:spPr>
          <a:xfrm>
            <a:off x="1492260" y="6362457"/>
            <a:ext cx="91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Palatino Linotype" panose="02040502050505030304" pitchFamily="18" charset="0"/>
                <a:ea typeface="ＭＳ ゴシック" panose="020B0609070205080204" pitchFamily="49" charset="-128"/>
                <a:cs typeface="Arial" panose="020B0604020202020204" pitchFamily="34" charset="0"/>
              </a:rPr>
              <a:t>Figure S1.  Flowchart showing recruitment of patients, allocation and dropout</a:t>
            </a:r>
            <a:endParaRPr lang="ja-JP" altLang="en-US" sz="2000" dirty="0">
              <a:latin typeface="Palatino Linotype" panose="02040502050505030304" pitchFamily="18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E563662-1E39-C44A-8489-0ADBAB5249A5}"/>
              </a:ext>
            </a:extLst>
          </p:cNvPr>
          <p:cNvGrpSpPr/>
          <p:nvPr/>
        </p:nvGrpSpPr>
        <p:grpSpPr>
          <a:xfrm>
            <a:off x="1341128" y="154133"/>
            <a:ext cx="9509743" cy="5958213"/>
            <a:chOff x="-236337" y="683353"/>
            <a:chExt cx="9509743" cy="5958213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D2007289-7D28-7941-B3DB-5E54537302CC}"/>
                </a:ext>
              </a:extLst>
            </p:cNvPr>
            <p:cNvGrpSpPr/>
            <p:nvPr/>
          </p:nvGrpSpPr>
          <p:grpSpPr>
            <a:xfrm>
              <a:off x="-236337" y="683353"/>
              <a:ext cx="9509743" cy="5958213"/>
              <a:chOff x="-236337" y="683353"/>
              <a:chExt cx="9509743" cy="5958213"/>
            </a:xfrm>
          </p:grpSpPr>
          <p:grpSp>
            <p:nvGrpSpPr>
              <p:cNvPr id="64" name="グループ化 63">
                <a:extLst>
                  <a:ext uri="{FF2B5EF4-FFF2-40B4-BE49-F238E27FC236}">
                    <a16:creationId xmlns:a16="http://schemas.microsoft.com/office/drawing/2014/main" id="{A56B1B18-519B-48B1-A4CA-A98C37A536AE}"/>
                  </a:ext>
                </a:extLst>
              </p:cNvPr>
              <p:cNvGrpSpPr/>
              <p:nvPr/>
            </p:nvGrpSpPr>
            <p:grpSpPr>
              <a:xfrm>
                <a:off x="-236337" y="683353"/>
                <a:ext cx="9509743" cy="5390554"/>
                <a:chOff x="102193" y="686150"/>
                <a:chExt cx="9509743" cy="5390554"/>
              </a:xfrm>
            </p:grpSpPr>
            <p:sp>
              <p:nvSpPr>
                <p:cNvPr id="7" name="正方形/長方形 6">
                  <a:extLst>
                    <a:ext uri="{FF2B5EF4-FFF2-40B4-BE49-F238E27FC236}">
                      <a16:creationId xmlns:a16="http://schemas.microsoft.com/office/drawing/2014/main" id="{E869F447-5F07-43B9-8DC0-B559CCCD95E4}"/>
                    </a:ext>
                  </a:extLst>
                </p:cNvPr>
                <p:cNvSpPr/>
                <p:nvPr/>
              </p:nvSpPr>
              <p:spPr>
                <a:xfrm>
                  <a:off x="3298825" y="2712924"/>
                  <a:ext cx="2546350" cy="27305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pPr algn="ctr"/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Randomizati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30)</a:t>
                  </a:r>
                  <a:endParaRPr lang="ja-JP" altLang="en-US" sz="1600" dirty="0">
                    <a:solidFill>
                      <a:schemeClr val="tx1"/>
                    </a:solidFill>
                    <a:latin typeface="Lucida Bright" panose="02040602050505020304" pitchFamily="18" charset="0"/>
                    <a:ea typeface="ＭＳ ゴシック" panose="020B0609070205080204" pitchFamily="49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正方形/長方形 7">
                  <a:extLst>
                    <a:ext uri="{FF2B5EF4-FFF2-40B4-BE49-F238E27FC236}">
                      <a16:creationId xmlns:a16="http://schemas.microsoft.com/office/drawing/2014/main" id="{87499F99-189E-449E-B2B1-DFE6497E9991}"/>
                    </a:ext>
                  </a:extLst>
                </p:cNvPr>
                <p:cNvSpPr/>
                <p:nvPr/>
              </p:nvSpPr>
              <p:spPr>
                <a:xfrm>
                  <a:off x="2955073" y="686150"/>
                  <a:ext cx="3256156" cy="27305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pPr algn="ctr"/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Assessment of eligibility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35)</a:t>
                  </a:r>
                  <a:endParaRPr lang="ja-JP" altLang="en-US" sz="1600" dirty="0">
                    <a:solidFill>
                      <a:schemeClr val="tx1"/>
                    </a:solidFill>
                    <a:latin typeface="Lucida Bright" panose="02040602050505020304" pitchFamily="18" charset="0"/>
                    <a:ea typeface="ＭＳ ゴシック" panose="020B0609070205080204" pitchFamily="49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正方形/長方形 8">
                  <a:extLst>
                    <a:ext uri="{FF2B5EF4-FFF2-40B4-BE49-F238E27FC236}">
                      <a16:creationId xmlns:a16="http://schemas.microsoft.com/office/drawing/2014/main" id="{8D03DBC7-3CD0-4127-B268-8E9B09AEF481}"/>
                    </a:ext>
                  </a:extLst>
                </p:cNvPr>
                <p:cNvSpPr/>
                <p:nvPr/>
              </p:nvSpPr>
              <p:spPr>
                <a:xfrm>
                  <a:off x="5029197" y="1256391"/>
                  <a:ext cx="4248403" cy="1159342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Excluded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5)</a:t>
                  </a:r>
                </a:p>
                <a:p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Not meeting the inclusion criteria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4)</a:t>
                  </a:r>
                </a:p>
                <a:p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Decline to participate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1)</a:t>
                  </a:r>
                </a:p>
                <a:p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Other reas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0)</a:t>
                  </a:r>
                </a:p>
              </p:txBody>
            </p:sp>
            <p:sp>
              <p:nvSpPr>
                <p:cNvPr id="13" name="正方形/長方形 12">
                  <a:extLst>
                    <a:ext uri="{FF2B5EF4-FFF2-40B4-BE49-F238E27FC236}">
                      <a16:creationId xmlns:a16="http://schemas.microsoft.com/office/drawing/2014/main" id="{5B004FAD-92CE-4FCD-849B-6DE9CA3DA582}"/>
                    </a:ext>
                  </a:extLst>
                </p:cNvPr>
                <p:cNvSpPr/>
                <p:nvPr/>
              </p:nvSpPr>
              <p:spPr>
                <a:xfrm>
                  <a:off x="102193" y="3589338"/>
                  <a:ext cx="4454440" cy="1030636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Allocated to CPC Mouth Wash Group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15)</a:t>
                  </a:r>
                </a:p>
                <a:p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Received allocation interventi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15)</a:t>
                  </a:r>
                </a:p>
              </p:txBody>
            </p:sp>
            <p:sp>
              <p:nvSpPr>
                <p:cNvPr id="14" name="正方形/長方形 13">
                  <a:extLst>
                    <a:ext uri="{FF2B5EF4-FFF2-40B4-BE49-F238E27FC236}">
                      <a16:creationId xmlns:a16="http://schemas.microsoft.com/office/drawing/2014/main" id="{E360E98B-1B69-4FCB-ACC5-23A029D80FC2}"/>
                    </a:ext>
                  </a:extLst>
                </p:cNvPr>
                <p:cNvSpPr/>
                <p:nvPr/>
              </p:nvSpPr>
              <p:spPr>
                <a:xfrm>
                  <a:off x="4825326" y="3589338"/>
                  <a:ext cx="4786610" cy="1030635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Allocated to Placebo Mouth Wash Group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15)</a:t>
                  </a:r>
                </a:p>
                <a:p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Received allocation interventi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Lucida Bright" panose="02040602050505020304" pitchFamily="18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15)</a:t>
                  </a:r>
                </a:p>
              </p:txBody>
            </p:sp>
            <p:sp>
              <p:nvSpPr>
                <p:cNvPr id="15" name="正方形/長方形 14">
                  <a:extLst>
                    <a:ext uri="{FF2B5EF4-FFF2-40B4-BE49-F238E27FC236}">
                      <a16:creationId xmlns:a16="http://schemas.microsoft.com/office/drawing/2014/main" id="{861EFF15-CC0E-4FC9-A41B-21A93D257152}"/>
                    </a:ext>
                  </a:extLst>
                </p:cNvPr>
                <p:cNvSpPr/>
                <p:nvPr/>
              </p:nvSpPr>
              <p:spPr>
                <a:xfrm>
                  <a:off x="543460" y="5070548"/>
                  <a:ext cx="4013169" cy="555582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pPr algn="ctr"/>
                  <a:r>
                    <a:rPr lang="en-US" altLang="ja-JP" sz="1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Discontinued interventi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0)</a:t>
                  </a:r>
                  <a:endParaRPr lang="ja-JP" alt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正方形/長方形 15">
                  <a:extLst>
                    <a:ext uri="{FF2B5EF4-FFF2-40B4-BE49-F238E27FC236}">
                      <a16:creationId xmlns:a16="http://schemas.microsoft.com/office/drawing/2014/main" id="{03EDAE2F-9102-4FBE-B17F-434F56F08D98}"/>
                    </a:ext>
                  </a:extLst>
                </p:cNvPr>
                <p:cNvSpPr/>
                <p:nvPr/>
              </p:nvSpPr>
              <p:spPr>
                <a:xfrm>
                  <a:off x="4825325" y="5070140"/>
                  <a:ext cx="4043883" cy="555582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54000" tIns="54000" rIns="54000" bIns="54000" rtlCol="0" anchor="ctr"/>
                <a:lstStyle/>
                <a:p>
                  <a:pPr algn="ctr"/>
                  <a:r>
                    <a:rPr lang="en-US" altLang="ja-JP" sz="1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Discontinued intervention</a:t>
                  </a:r>
                  <a:r>
                    <a:rPr lang="ja-JP" altLang="en-US" sz="160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600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rPr>
                    <a:t>(n=0)</a:t>
                  </a:r>
                  <a:endParaRPr lang="ja-JP" alt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5" name="直線矢印コネクタ 34">
                  <a:extLst>
                    <a:ext uri="{FF2B5EF4-FFF2-40B4-BE49-F238E27FC236}">
                      <a16:creationId xmlns:a16="http://schemas.microsoft.com/office/drawing/2014/main" id="{49A9F0BD-FF74-4BC1-BC1E-438797038A5A}"/>
                    </a:ext>
                  </a:extLst>
                </p:cNvPr>
                <p:cNvCxnSpPr>
                  <a:cxnSpLocks/>
                  <a:stCxn id="8" idx="2"/>
                  <a:endCxn id="7" idx="0"/>
                </p:cNvCxnSpPr>
                <p:nvPr/>
              </p:nvCxnSpPr>
              <p:spPr>
                <a:xfrm flipH="1">
                  <a:off x="4572000" y="959200"/>
                  <a:ext cx="11151" cy="1753724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type="none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矢印コネクタ 38">
                  <a:extLst>
                    <a:ext uri="{FF2B5EF4-FFF2-40B4-BE49-F238E27FC236}">
                      <a16:creationId xmlns:a16="http://schemas.microsoft.com/office/drawing/2014/main" id="{A5597984-BEBD-494E-94D8-C1A7C3A45CE4}"/>
                    </a:ext>
                  </a:extLst>
                </p:cNvPr>
                <p:cNvCxnSpPr>
                  <a:cxnSpLocks/>
                  <a:endCxn id="9" idx="1"/>
                </p:cNvCxnSpPr>
                <p:nvPr/>
              </p:nvCxnSpPr>
              <p:spPr>
                <a:xfrm>
                  <a:off x="4572000" y="1836062"/>
                  <a:ext cx="457197" cy="0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type="none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直線矢印コネクタ 46">
                  <a:extLst>
                    <a:ext uri="{FF2B5EF4-FFF2-40B4-BE49-F238E27FC236}">
                      <a16:creationId xmlns:a16="http://schemas.microsoft.com/office/drawing/2014/main" id="{6F94A305-8610-48C2-B4DF-51910DC2AA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19921" y="5650692"/>
                  <a:ext cx="0" cy="426012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type="none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直線矢印コネクタ 53">
                  <a:extLst>
                    <a:ext uri="{FF2B5EF4-FFF2-40B4-BE49-F238E27FC236}">
                      <a16:creationId xmlns:a16="http://schemas.microsoft.com/office/drawing/2014/main" id="{EE8E2768-B23F-4050-8F6B-3275F0C9ED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12930" y="5648432"/>
                  <a:ext cx="0" cy="426012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headEnd type="none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右中かっこ 62">
                  <a:extLst>
                    <a:ext uri="{FF2B5EF4-FFF2-40B4-BE49-F238E27FC236}">
                      <a16:creationId xmlns:a16="http://schemas.microsoft.com/office/drawing/2014/main" id="{B9C26BC4-A70D-44C1-8E29-5E379DCAFF0D}"/>
                    </a:ext>
                  </a:extLst>
                </p:cNvPr>
                <p:cNvSpPr/>
                <p:nvPr/>
              </p:nvSpPr>
              <p:spPr>
                <a:xfrm rot="16200000">
                  <a:off x="4270318" y="1146726"/>
                  <a:ext cx="603364" cy="4281860"/>
                </a:xfrm>
                <a:prstGeom prst="rightBrace">
                  <a:avLst>
                    <a:gd name="adj1" fmla="val 0"/>
                    <a:gd name="adj2" fmla="val 50000"/>
                  </a:avLst>
                </a:prstGeom>
                <a:ln w="19050">
                  <a:solidFill>
                    <a:schemeClr val="tx1"/>
                  </a:solidFill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ja-JP" altLang="en-US"/>
                </a:p>
              </p:txBody>
            </p:sp>
          </p:grpSp>
          <p:sp>
            <p:nvSpPr>
              <p:cNvPr id="32" name="正方形/長方形 31">
                <a:extLst>
                  <a:ext uri="{FF2B5EF4-FFF2-40B4-BE49-F238E27FC236}">
                    <a16:creationId xmlns:a16="http://schemas.microsoft.com/office/drawing/2014/main" id="{AA1AFEF9-3A1A-764E-B03F-91282E26F428}"/>
                  </a:ext>
                </a:extLst>
              </p:cNvPr>
              <p:cNvSpPr/>
              <p:nvPr/>
            </p:nvSpPr>
            <p:spPr>
              <a:xfrm>
                <a:off x="193785" y="6085984"/>
                <a:ext cx="4013163" cy="555582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54000" tIns="54000" rIns="54000" bIns="54000" rtlCol="0" anchor="ctr"/>
              <a:lstStyle/>
              <a:p>
                <a:pPr algn="ctr"/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Analyzed</a:t>
                </a:r>
                <a:r>
                  <a:rPr lang="ja-JP" altLang="en-US" sz="160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(n=15)                    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" name="正方形/長方形 32">
                <a:extLst>
                  <a:ext uri="{FF2B5EF4-FFF2-40B4-BE49-F238E27FC236}">
                    <a16:creationId xmlns:a16="http://schemas.microsoft.com/office/drawing/2014/main" id="{06C17651-5EE0-B24A-9F4F-2403463E6345}"/>
                  </a:ext>
                </a:extLst>
              </p:cNvPr>
              <p:cNvSpPr/>
              <p:nvPr/>
            </p:nvSpPr>
            <p:spPr>
              <a:xfrm>
                <a:off x="4462068" y="6085984"/>
                <a:ext cx="4043871" cy="555582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54000" tIns="54000" rIns="54000" bIns="54000" rtlCol="0" anchor="ctr"/>
              <a:lstStyle/>
              <a:p>
                <a:pPr algn="ctr"/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Analyzed</a:t>
                </a:r>
                <a:r>
                  <a:rPr lang="ja-JP" altLang="en-US" sz="160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 </a:t>
                </a:r>
                <a:r>
                  <a:rPr lang="en-US" altLang="ja-JP" sz="1600" dirty="0">
                    <a:solidFill>
                      <a:schemeClr val="tx1"/>
                    </a:solidFill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(n=15)</a:t>
                </a:r>
                <a:endParaRPr lang="ja-JP" altLang="en-US" sz="1600" dirty="0">
                  <a:solidFill>
                    <a:schemeClr val="tx1"/>
                  </a:solidFill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757BF51F-915D-424C-98F9-186579013DC2}"/>
                </a:ext>
              </a:extLst>
            </p:cNvPr>
            <p:cNvCxnSpPr>
              <a:cxnSpLocks/>
            </p:cNvCxnSpPr>
            <p:nvPr/>
          </p:nvCxnSpPr>
          <p:spPr>
            <a:xfrm>
              <a:off x="2081389" y="4641331"/>
              <a:ext cx="0" cy="426012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none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F55E2B28-2CF9-D94D-A62A-BE6D76BCBC0E}"/>
                </a:ext>
              </a:extLst>
            </p:cNvPr>
            <p:cNvCxnSpPr>
              <a:cxnSpLocks/>
            </p:cNvCxnSpPr>
            <p:nvPr/>
          </p:nvCxnSpPr>
          <p:spPr>
            <a:xfrm>
              <a:off x="6374398" y="4641331"/>
              <a:ext cx="0" cy="426012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none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70287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329A84-B48E-0F9B-FC52-3B723E761270}"/>
              </a:ext>
            </a:extLst>
          </p:cNvPr>
          <p:cNvSpPr txBox="1"/>
          <p:nvPr/>
        </p:nvSpPr>
        <p:spPr>
          <a:xfrm>
            <a:off x="2938041" y="175571"/>
            <a:ext cx="49925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Palatino Linotype" panose="02040502050505030304" pitchFamily="18" charset="0"/>
                <a:ea typeface="ＭＳ ゴシック" panose="020B0609070205080204" pitchFamily="49" charset="-128"/>
                <a:cs typeface="Arial" panose="020B0604020202020204" pitchFamily="34" charset="0"/>
              </a:rPr>
              <a:t>Table S1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ults of tests on normality of data</a:t>
            </a:r>
            <a:r>
              <a:rPr lang="ja-JP" altLang="ja-JP" sz="2000">
                <a:effectLst/>
              </a:rPr>
              <a:t> </a:t>
            </a:r>
            <a:endParaRPr lang="ja-JP" altLang="en-US" sz="2000" dirty="0">
              <a:latin typeface="Palatino Linotype" panose="02040502050505030304" pitchFamily="18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1A265668-1F12-80BB-7772-2131B69517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5278302"/>
              </p:ext>
            </p:extLst>
          </p:nvPr>
        </p:nvGraphicFramePr>
        <p:xfrm>
          <a:off x="1819154" y="1499011"/>
          <a:ext cx="8553691" cy="397105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2979664">
                  <a:extLst>
                    <a:ext uri="{9D8B030D-6E8A-4147-A177-3AD203B41FA5}">
                      <a16:colId xmlns:a16="http://schemas.microsoft.com/office/drawing/2014/main" val="2963682313"/>
                    </a:ext>
                  </a:extLst>
                </a:gridCol>
                <a:gridCol w="2013843">
                  <a:extLst>
                    <a:ext uri="{9D8B030D-6E8A-4147-A177-3AD203B41FA5}">
                      <a16:colId xmlns:a16="http://schemas.microsoft.com/office/drawing/2014/main" val="3200127000"/>
                    </a:ext>
                  </a:extLst>
                </a:gridCol>
                <a:gridCol w="2018979">
                  <a:extLst>
                    <a:ext uri="{9D8B030D-6E8A-4147-A177-3AD203B41FA5}">
                      <a16:colId xmlns:a16="http://schemas.microsoft.com/office/drawing/2014/main" val="2446106000"/>
                    </a:ext>
                  </a:extLst>
                </a:gridCol>
                <a:gridCol w="1541205">
                  <a:extLst>
                    <a:ext uri="{9D8B030D-6E8A-4147-A177-3AD203B41FA5}">
                      <a16:colId xmlns:a16="http://schemas.microsoft.com/office/drawing/2014/main" val="3149083652"/>
                    </a:ext>
                  </a:extLst>
                </a:gridCol>
              </a:tblGrid>
              <a:tr h="424093">
                <a:tc rowSpan="2">
                  <a:txBody>
                    <a:bodyPr/>
                    <a:lstStyle/>
                    <a:p>
                      <a:pPr algn="l" fontAlgn="b"/>
                      <a:r>
                        <a:rPr lang="ja-JP" altLang="en-US" sz="900" u="none" strike="noStrike">
                          <a:effectLst/>
                        </a:rPr>
                        <a:t>　</a:t>
                      </a:r>
                      <a:endParaRPr lang="ja-JP" altLang="en-US" sz="900" b="0" i="0" u="none" strike="noStrike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" sz="1800" u="none" strike="noStrike" dirty="0">
                          <a:effectLst/>
                          <a:latin typeface="Palatino Linotype" panose="02040502050505030304" pitchFamily="18" charset="0"/>
                        </a:rPr>
                        <a:t>Shapiro-Wilk test</a:t>
                      </a:r>
                      <a:endParaRPr lang="en" sz="18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2987548"/>
                  </a:ext>
                </a:extLst>
              </a:tr>
              <a:tr h="38553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Statistics</a:t>
                      </a:r>
                      <a:endParaRPr lang="en" sz="14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Degrees of freedom</a:t>
                      </a:r>
                      <a:endParaRPr lang="en" sz="14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P-value</a:t>
                      </a:r>
                      <a:endParaRPr lang="en" sz="14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97681992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r>
                        <a:rPr lang="en" sz="1600" u="none" strike="noStrike" baseline="-25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S (ppb)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932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05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74320192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CH</a:t>
                      </a:r>
                      <a:r>
                        <a:rPr lang="en" sz="1600" u="none" strike="noStrike" baseline="-2500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SH (ppb)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929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04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46151738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(CH</a:t>
                      </a:r>
                      <a:r>
                        <a:rPr lang="en" sz="1600" u="none" strike="noStrike" baseline="-2500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r>
                        <a:rPr lang="en" sz="1600" u="none" strike="noStrike" baseline="-25000" dirty="0"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S (ppb)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832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&lt; 0.00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33399097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Total VSCs (ppb)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930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04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51643711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PI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920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02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59208639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GI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846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00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3811441"/>
                  </a:ext>
                </a:extLst>
              </a:tr>
              <a:tr h="385539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TCI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961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3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50048104"/>
                  </a:ext>
                </a:extLst>
              </a:tr>
              <a:tr h="462647">
                <a:tc>
                  <a:txBody>
                    <a:bodyPr/>
                    <a:lstStyle/>
                    <a:p>
                      <a:pPr algn="ctr" fontAlgn="ctr"/>
                      <a:r>
                        <a:rPr lang="en" sz="1600" u="none" strike="noStrike" dirty="0">
                          <a:effectLst/>
                          <a:latin typeface="Palatino Linotype" panose="02040502050505030304" pitchFamily="18" charset="0"/>
                        </a:rPr>
                        <a:t>Unstimulated saliva (ml)</a:t>
                      </a:r>
                      <a:endParaRPr lang="en" sz="1600" b="1" i="0" u="none" strike="noStrike" dirty="0">
                        <a:solidFill>
                          <a:srgbClr val="264A6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Palatino Linotype" panose="02040502050505030304" pitchFamily="18" charset="0"/>
                        </a:rPr>
                        <a:t>0.674</a:t>
                      </a:r>
                      <a:endParaRPr lang="en-US" altLang="ja-JP" sz="1400" b="0" i="0" u="none" strike="noStrike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30</a:t>
                      </a:r>
                      <a:endParaRPr lang="en-US" altLang="ja-JP" sz="1400" b="0" i="0" u="none" strike="noStrike" dirty="0">
                        <a:solidFill>
                          <a:srgbClr val="010205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0.00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01954527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888563C-2CFC-0243-4165-3A1DE5C17082}"/>
              </a:ext>
            </a:extLst>
          </p:cNvPr>
          <p:cNvSpPr txBox="1"/>
          <p:nvPr/>
        </p:nvSpPr>
        <p:spPr>
          <a:xfrm>
            <a:off x="3842793" y="575681"/>
            <a:ext cx="49925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fontAlgn="t"/>
            <a:r>
              <a:rPr lang="en" altLang="ja-JP" sz="1400" u="none" strike="noStrike" dirty="0">
                <a:effectLst/>
                <a:latin typeface="Palatino Linotype" panose="02040502050505030304" pitchFamily="18" charset="0"/>
              </a:rPr>
              <a:t>*. Indicates the lower limit of the true significance level.</a:t>
            </a:r>
          </a:p>
          <a:p>
            <a:pPr fontAlgn="t"/>
            <a:r>
              <a:rPr lang="en" altLang="ja-JP" sz="1400" u="none" strike="noStrike" dirty="0">
                <a:effectLst/>
                <a:latin typeface="Palatino Linotype" panose="02040502050505030304" pitchFamily="18" charset="0"/>
              </a:rPr>
              <a:t>a. Lilliefors significance correction</a:t>
            </a:r>
            <a:endParaRPr lang="en" altLang="ja-JP" sz="1400" b="0" i="0" u="none" strike="noStrike" dirty="0">
              <a:solidFill>
                <a:srgbClr val="010205"/>
              </a:solidFill>
              <a:effectLst/>
              <a:latin typeface="Palatino Linotype" panose="02040502050505030304" pitchFamily="18" charset="0"/>
              <a:ea typeface="游ゴシック" panose="020B0400000000000000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35171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</TotalTime>
  <Words>209</Words>
  <Application>Microsoft Macintosh PowerPoint</Application>
  <PresentationFormat>ワイド画面</PresentationFormat>
  <Paragraphs>5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Lucida Bright</vt:lpstr>
      <vt:lpstr>Palatino Linotype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義明</dc:creator>
  <cp:lastModifiedBy>雄大 新保</cp:lastModifiedBy>
  <cp:revision>95</cp:revision>
  <dcterms:created xsi:type="dcterms:W3CDTF">2021-11-12T04:19:14Z</dcterms:created>
  <dcterms:modified xsi:type="dcterms:W3CDTF">2025-05-12T16:11:51Z</dcterms:modified>
</cp:coreProperties>
</file>